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5" r:id="rId2"/>
    <p:sldId id="276" r:id="rId3"/>
    <p:sldId id="270" r:id="rId4"/>
    <p:sldId id="262" r:id="rId5"/>
    <p:sldId id="261" r:id="rId6"/>
    <p:sldId id="267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6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57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ingqian Zhang" userId="e0887475aeffad42" providerId="LiveId" clId="{008D5354-1B3F-46E4-8FCB-26A1613EAE64}"/>
    <pc:docChg chg="modSld">
      <pc:chgData name="Yingqian Zhang" userId="e0887475aeffad42" providerId="LiveId" clId="{008D5354-1B3F-46E4-8FCB-26A1613EAE64}" dt="2025-12-15T13:46:25.595" v="38" actId="1076"/>
      <pc:docMkLst>
        <pc:docMk/>
      </pc:docMkLst>
      <pc:sldChg chg="modSp mod">
        <pc:chgData name="Yingqian Zhang" userId="e0887475aeffad42" providerId="LiveId" clId="{008D5354-1B3F-46E4-8FCB-26A1613EAE64}" dt="2025-12-15T09:28:17.463" v="9" actId="1076"/>
        <pc:sldMkLst>
          <pc:docMk/>
          <pc:sldMk cId="3658409412" sldId="267"/>
        </pc:sldMkLst>
        <pc:spChg chg="mod">
          <ac:chgData name="Yingqian Zhang" userId="e0887475aeffad42" providerId="LiveId" clId="{008D5354-1B3F-46E4-8FCB-26A1613EAE64}" dt="2025-12-15T09:28:17.463" v="9" actId="1076"/>
          <ac:spMkLst>
            <pc:docMk/>
            <pc:sldMk cId="3658409412" sldId="267"/>
            <ac:spMk id="4" creationId="{E5B0F025-3DBB-6663-C205-068B18143287}"/>
          </ac:spMkLst>
        </pc:spChg>
      </pc:sldChg>
      <pc:sldChg chg="modSp mod">
        <pc:chgData name="Yingqian Zhang" userId="e0887475aeffad42" providerId="LiveId" clId="{008D5354-1B3F-46E4-8FCB-26A1613EAE64}" dt="2025-12-15T09:26:59.998" v="3" actId="1076"/>
        <pc:sldMkLst>
          <pc:docMk/>
          <pc:sldMk cId="3683310703" sldId="270"/>
        </pc:sldMkLst>
        <pc:spChg chg="mod">
          <ac:chgData name="Yingqian Zhang" userId="e0887475aeffad42" providerId="LiveId" clId="{008D5354-1B3F-46E4-8FCB-26A1613EAE64}" dt="2025-12-15T09:26:49.335" v="0" actId="1076"/>
          <ac:spMkLst>
            <pc:docMk/>
            <pc:sldMk cId="3683310703" sldId="270"/>
            <ac:spMk id="2" creationId="{F635D96F-4EE4-55BB-23BD-F307144710BD}"/>
          </ac:spMkLst>
        </pc:spChg>
        <pc:picChg chg="mod modCrop">
          <ac:chgData name="Yingqian Zhang" userId="e0887475aeffad42" providerId="LiveId" clId="{008D5354-1B3F-46E4-8FCB-26A1613EAE64}" dt="2025-12-15T09:26:59.998" v="3" actId="1076"/>
          <ac:picMkLst>
            <pc:docMk/>
            <pc:sldMk cId="3683310703" sldId="270"/>
            <ac:picMk id="3" creationId="{9DAA9EAB-9298-08FA-6906-596687ACCEF6}"/>
          </ac:picMkLst>
        </pc:picChg>
      </pc:sldChg>
      <pc:sldChg chg="modSp mod">
        <pc:chgData name="Yingqian Zhang" userId="e0887475aeffad42" providerId="LiveId" clId="{008D5354-1B3F-46E4-8FCB-26A1613EAE64}" dt="2025-12-15T13:46:25.595" v="38" actId="1076"/>
        <pc:sldMkLst>
          <pc:docMk/>
          <pc:sldMk cId="947037840" sldId="276"/>
        </pc:sldMkLst>
        <pc:spChg chg="mod">
          <ac:chgData name="Yingqian Zhang" userId="e0887475aeffad42" providerId="LiveId" clId="{008D5354-1B3F-46E4-8FCB-26A1613EAE64}" dt="2025-12-15T09:27:40.592" v="7" actId="1076"/>
          <ac:spMkLst>
            <pc:docMk/>
            <pc:sldMk cId="947037840" sldId="276"/>
            <ac:spMk id="2" creationId="{0EA4241A-7D51-A0ED-E565-0057C50D4558}"/>
          </ac:spMkLst>
        </pc:spChg>
        <pc:spChg chg="mod">
          <ac:chgData name="Yingqian Zhang" userId="e0887475aeffad42" providerId="LiveId" clId="{008D5354-1B3F-46E4-8FCB-26A1613EAE64}" dt="2025-12-15T13:46:25.595" v="38" actId="1076"/>
          <ac:spMkLst>
            <pc:docMk/>
            <pc:sldMk cId="947037840" sldId="276"/>
            <ac:spMk id="8" creationId="{CC678F83-71C8-CA0F-BD5F-5B5A6F2F37C4}"/>
          </ac:spMkLst>
        </pc:spChg>
        <pc:graphicFrameChg chg="mod modGraphic">
          <ac:chgData name="Yingqian Zhang" userId="e0887475aeffad42" providerId="LiveId" clId="{008D5354-1B3F-46E4-8FCB-26A1613EAE64}" dt="2025-12-15T13:46:14.338" v="37" actId="1076"/>
          <ac:graphicFrameMkLst>
            <pc:docMk/>
            <pc:sldMk cId="947037840" sldId="276"/>
            <ac:graphicFrameMk id="5" creationId="{D2A82864-6315-1472-0B53-2EEBC6385191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08B6EB-7E24-0169-3645-AF8A895D2FF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B6EC83C-563B-AAB2-0221-0E361B4B40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7763D9-88CA-2DC3-3F2F-8A34200555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FB50C-065F-44C8-8C02-E0F1065C79AC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6D5372-A2EA-0920-C57F-76281348CD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3AC249-FBDD-2CD1-2544-3B66866498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1D7C5-ED4F-4C15-A9B8-390845D79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8901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E2E912-F69B-F373-B9C4-958A312D94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12B7050-7F8F-7448-F1C4-A6E67A3A68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36D8C4-97CF-DB17-B33E-8FFC549D04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FB50C-065F-44C8-8C02-E0F1065C79AC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5F25EB-E316-30A3-890C-40AB49DCB6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C711FE-E4DC-53C9-7780-8CA84B84A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1D7C5-ED4F-4C15-A9B8-390845D79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6502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6E4A908-E0F3-7488-C967-EE8183CFCB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585ED76-7BD3-7031-719D-3A4A2C07DE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E3092B-181E-2515-9ABD-2059497723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FB50C-065F-44C8-8C02-E0F1065C79AC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97F150-CBFE-5978-46D5-4C63010B19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44BD3B-EFCB-4CFC-359E-5F210B2EA2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1D7C5-ED4F-4C15-A9B8-390845D79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2167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C20285-59D6-E1E8-40B2-5AF10984D0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009BBC-F4C9-3B66-044F-68E7A38D48C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9ECAC3-A346-EA51-E223-96B2AE83E9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FB50C-065F-44C8-8C02-E0F1065C79AC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036F3E-ECFF-0E07-10B6-EF51B3D4C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915B4C-2704-9E7A-BD5F-12619D92E2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1D7C5-ED4F-4C15-A9B8-390845D79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28229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9BAF8A-6B83-E736-54ED-7C3BFD5F93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108663-EE52-0C66-0BDD-A1CBF394FD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DDD515-B0C4-A4ED-4C0C-447FBCE9C5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FB50C-065F-44C8-8C02-E0F1065C79AC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F97CD7-1C48-EBA7-AF0A-99258FF86C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C8DD36-4E0C-788D-8B4D-877F8BDAF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1D7C5-ED4F-4C15-A9B8-390845D79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89686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491731-879E-0052-3AF3-0C983CEACC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AF600F-891F-08F8-8E3D-AA71DDF4858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3809AB0-8CE9-85A2-4426-8231D3DE71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E760C6-5579-9A9C-ECC4-F88324BB02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FB50C-065F-44C8-8C02-E0F1065C79AC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124857-342B-3BF8-7D01-2DBEFF374E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5FC582-96AB-E7B0-E468-4AB4F289BA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1D7C5-ED4F-4C15-A9B8-390845D79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2114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7B73AA-ED6A-7CBA-20E1-BC0FE27932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9DEDA5-318F-5081-8C74-6757F73FEE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6DD72A-5ECA-1EBF-3CBA-36D388D789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E67AFC2-F553-A075-76CA-8C8FFCBE84B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18225CD-8327-8C73-3A4D-C9FACA496E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3787254-9043-B74F-CA18-EF38195D06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FB50C-065F-44C8-8C02-E0F1065C79AC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1EF8E5D-4004-554D-0DA3-3623BD73B4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66CB400-60BF-48B0-9295-DC9DB04B8A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1D7C5-ED4F-4C15-A9B8-390845D79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36079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BDCB81-639D-FD3E-F922-60AD5B7458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E0B0FB4-EE91-EEA1-EF92-DA01D5C578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FB50C-065F-44C8-8C02-E0F1065C79AC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AE94109-EFAD-16D7-734F-FED6240398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3F71DEF-E77A-93D5-1F85-DB7403235C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1D7C5-ED4F-4C15-A9B8-390845D79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44806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C282CE2-F26E-65AA-5B5B-25345FA4A5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FB50C-065F-44C8-8C02-E0F1065C79AC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BA62B38-C7F2-51BB-EF63-5035181CA5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43CFF96-C5E3-85AA-5974-780EFDE4A2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1D7C5-ED4F-4C15-A9B8-390845D79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3969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F5D549-A8F2-FAE4-0CF2-6414032393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9B4386-D982-0B69-B2A9-AAF6F749E27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34C6DBA-2BEC-7471-35C4-8A41059D00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6D47B2-0359-070F-2BC0-19475345E6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FB50C-065F-44C8-8C02-E0F1065C79AC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2AAEF8-99DA-A002-03DF-A3356ECF1C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249F30B-4843-02FD-90A8-BAA2953A06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1D7C5-ED4F-4C15-A9B8-390845D79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3414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06A848-D1C2-ED9B-8DED-79EE607A67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C4153E3-192D-7A00-81D6-AE32A93DB3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E814DC-60A0-5DD3-6E58-A1732C8FC0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12859E-973E-B857-632B-C3614A5EA2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FB50C-065F-44C8-8C02-E0F1065C79AC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E0B0FF-7841-6DC2-DBD9-17F15719CA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3B6454-E8BF-063A-3101-143FCE7245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1D7C5-ED4F-4C15-A9B8-390845D79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72595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B00C000-E069-5CA3-DDC9-D96A45848A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6E25B4-3284-EA48-D4FB-4FC9CAC66B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2224CE-4795-6F1A-DF88-FEC8D0B2F0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8DFB50C-065F-44C8-8C02-E0F1065C79AC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E057E8-D341-F57A-A1E7-02E94B4C77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550789-5CD9-FFC3-FC97-6391FA6D74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A1D7C5-ED4F-4C15-A9B8-390845D79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6464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A79BE22-11B6-5D0E-9E74-7FF8658C0A46}"/>
              </a:ext>
            </a:extLst>
          </p:cNvPr>
          <p:cNvSpPr txBox="1"/>
          <p:nvPr/>
        </p:nvSpPr>
        <p:spPr>
          <a:xfrm>
            <a:off x="1821425" y="1759343"/>
            <a:ext cx="8716297" cy="27779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b="1" dirty="0"/>
              <a:t>Peripheral Metabolic–Redox Signaling as a Core Mechanism of Major Depressive Disorder: Evidence From Deep Metabolomic Phenotyping</a:t>
            </a:r>
            <a:endParaRPr lang="en-US" dirty="0"/>
          </a:p>
          <a:p>
            <a:pPr algn="just">
              <a:lnSpc>
                <a:spcPct val="200000"/>
              </a:lnSpc>
              <a:buNone/>
            </a:pP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buNone/>
            </a:pPr>
            <a:r>
              <a:rPr lang="en-US" sz="1800" dirty="0">
                <a:effectLst/>
                <a:latin typeface="Times New Roman" panose="02020603050405020304" pitchFamily="18" charset="0"/>
                <a:ea typeface="CIDFont+F2"/>
              </a:rPr>
              <a:t>Michael Maes,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ngqi Niu,  Annabel Maes, </a:t>
            </a:r>
            <a:r>
              <a:rPr lang="en-US" sz="1800" dirty="0">
                <a:effectLst/>
                <a:latin typeface="Times New Roman" panose="02020603050405020304" pitchFamily="18" charset="0"/>
                <a:ea typeface="Microsoft YaHei" panose="020B0503020204020204" pitchFamily="34" charset="-122"/>
              </a:rPr>
              <a:t>Yiping Luo,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henkai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Yangyang, Jing Li, Abbas F. Almulla, Yingqian Zhang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F02FF31-E72D-5FF0-9567-D29848181A51}"/>
              </a:ext>
            </a:extLst>
          </p:cNvPr>
          <p:cNvSpPr txBox="1"/>
          <p:nvPr/>
        </p:nvSpPr>
        <p:spPr>
          <a:xfrm>
            <a:off x="2750574" y="796413"/>
            <a:ext cx="63934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ELECTRONIC SUPPLEMENTARY FILE (ESF)</a:t>
            </a:r>
          </a:p>
        </p:txBody>
      </p:sp>
    </p:spTree>
    <p:extLst>
      <p:ext uri="{BB962C8B-B14F-4D97-AF65-F5344CB8AC3E}">
        <p14:creationId xmlns:p14="http://schemas.microsoft.com/office/powerpoint/2010/main" val="13032833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EA4241A-7D51-A0ED-E565-0057C50D4558}"/>
              </a:ext>
            </a:extLst>
          </p:cNvPr>
          <p:cNvSpPr txBox="1"/>
          <p:nvPr/>
        </p:nvSpPr>
        <p:spPr>
          <a:xfrm>
            <a:off x="731931" y="640417"/>
            <a:ext cx="1056722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/>
              <a:t>ESF, Table 1</a:t>
            </a:r>
            <a:r>
              <a:rPr lang="en-US" sz="1500" dirty="0"/>
              <a:t>. Demographic and clinical data of patients and controls.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D2A82864-6315-1472-0B53-2EEBC638519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43771058"/>
              </p:ext>
            </p:extLst>
          </p:nvPr>
        </p:nvGraphicFramePr>
        <p:xfrm>
          <a:off x="1134268" y="1347056"/>
          <a:ext cx="9325192" cy="389839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076709">
                  <a:extLst>
                    <a:ext uri="{9D8B030D-6E8A-4147-A177-3AD203B41FA5}">
                      <a16:colId xmlns:a16="http://schemas.microsoft.com/office/drawing/2014/main" val="106154175"/>
                    </a:ext>
                  </a:extLst>
                </a:gridCol>
                <a:gridCol w="1444308">
                  <a:extLst>
                    <a:ext uri="{9D8B030D-6E8A-4147-A177-3AD203B41FA5}">
                      <a16:colId xmlns:a16="http://schemas.microsoft.com/office/drawing/2014/main" val="3755509334"/>
                    </a:ext>
                  </a:extLst>
                </a:gridCol>
                <a:gridCol w="1443629">
                  <a:extLst>
                    <a:ext uri="{9D8B030D-6E8A-4147-A177-3AD203B41FA5}">
                      <a16:colId xmlns:a16="http://schemas.microsoft.com/office/drawing/2014/main" val="3782787700"/>
                    </a:ext>
                  </a:extLst>
                </a:gridCol>
                <a:gridCol w="1150965">
                  <a:extLst>
                    <a:ext uri="{9D8B030D-6E8A-4147-A177-3AD203B41FA5}">
                      <a16:colId xmlns:a16="http://schemas.microsoft.com/office/drawing/2014/main" val="3034379776"/>
                    </a:ext>
                  </a:extLst>
                </a:gridCol>
                <a:gridCol w="1150965">
                  <a:extLst>
                    <a:ext uri="{9D8B030D-6E8A-4147-A177-3AD203B41FA5}">
                      <a16:colId xmlns:a16="http://schemas.microsoft.com/office/drawing/2014/main" val="3203596726"/>
                    </a:ext>
                  </a:extLst>
                </a:gridCol>
                <a:gridCol w="1058616">
                  <a:extLst>
                    <a:ext uri="{9D8B030D-6E8A-4147-A177-3AD203B41FA5}">
                      <a16:colId xmlns:a16="http://schemas.microsoft.com/office/drawing/2014/main" val="4490944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 dirty="0">
                          <a:effectLst/>
                        </a:rPr>
                        <a:t>Variables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HC (n = 40 )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MDD (n = 125 )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F/χ</a:t>
                      </a:r>
                      <a:r>
                        <a:rPr lang="en-US" sz="1400" kern="0" baseline="30000">
                          <a:effectLst/>
                        </a:rPr>
                        <a:t>2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df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p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29692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Age (years)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37.1 (13.8)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35.7 (12.1)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0.37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1/163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0.542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841075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Female / Male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27 / 13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87 / 38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0.06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1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0.802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452650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Marriage status (yes / no)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17 / 23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69 / 56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1.96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1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0.162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704509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 dirty="0">
                          <a:effectLst/>
                        </a:rPr>
                        <a:t>Living conditions (Urban / rural)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36 / 4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114 / 11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FET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-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0.760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026064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 dirty="0">
                          <a:effectLst/>
                        </a:rPr>
                        <a:t>Education (years)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13.9 (4.3)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13.5 (3.3)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0.26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1/163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0.613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638085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Metabolic syndromes (yes/no)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10 / 29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22 / 102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1.17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1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0.279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624201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Body mass index (kg/m</a:t>
                      </a:r>
                      <a:r>
                        <a:rPr lang="en-US" sz="1400" kern="0" baseline="30000">
                          <a:effectLst/>
                        </a:rPr>
                        <a:t>2</a:t>
                      </a:r>
                      <a:r>
                        <a:rPr lang="en-US" sz="1400" kern="0">
                          <a:effectLst/>
                        </a:rPr>
                        <a:t>)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23.52 (4.07)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22.30 (3.36)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3.58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1/163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 dirty="0">
                          <a:effectLst/>
                        </a:rPr>
                        <a:t>0.060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744503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Smoking (yes / no)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3 / 37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24 / 101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FET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-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0.091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696803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buNone/>
                      </a:pPr>
                      <a:r>
                        <a:rPr lang="en-US" sz="1400" kern="0" dirty="0">
                          <a:effectLst/>
                        </a:rPr>
                        <a:t>Overall severity of depression (z score)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 dirty="0">
                          <a:effectLst/>
                        </a:rPr>
                        <a:t>-1.464 (0.671)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0.537 (0.510) 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MWUT 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-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&lt;0.001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5542908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buNone/>
                      </a:pPr>
                      <a:r>
                        <a:rPr lang="en-US" sz="1400" kern="0" dirty="0">
                          <a:effectLst/>
                        </a:rPr>
                        <a:t>Physiosomatic symptoms (z score)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-1.300 (0.421)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 dirty="0">
                          <a:effectLst/>
                        </a:rPr>
                        <a:t>0.477 (0.671)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 dirty="0">
                          <a:effectLst/>
                        </a:rPr>
                        <a:t>MWUT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-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&lt;0.001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528629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 dirty="0">
                          <a:effectLst/>
                        </a:rPr>
                        <a:t>Current suicidal ideation (z score)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-0.774 (0.262)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0.269 (1.021)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 dirty="0">
                          <a:effectLst/>
                        </a:rPr>
                        <a:t>MWUT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-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&lt;0.001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6266818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buNone/>
                      </a:pPr>
                      <a:r>
                        <a:rPr lang="en-US" sz="1400" kern="0" dirty="0">
                          <a:effectLst/>
                        </a:rPr>
                        <a:t>Recurrence of illness (ROI) (z score)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-1.057 (0.150)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0.367 (0.903)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>
                          <a:effectLst/>
                        </a:rPr>
                        <a:t>MWUT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 dirty="0">
                          <a:effectLst/>
                        </a:rPr>
                        <a:t>-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400" kern="0" dirty="0">
                          <a:effectLst/>
                        </a:rPr>
                        <a:t>&lt;0.001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906321695"/>
                  </a:ext>
                </a:extLst>
              </a:tr>
            </a:tbl>
          </a:graphicData>
        </a:graphic>
      </p:graphicFrame>
      <p:sp>
        <p:nvSpPr>
          <p:cNvPr id="6" name="Rectangle 2">
            <a:extLst>
              <a:ext uri="{FF2B5EF4-FFF2-40B4-BE49-F238E27FC236}">
                <a16:creationId xmlns:a16="http://schemas.microsoft.com/office/drawing/2014/main" id="{6A29C1BB-C693-496D-5FAD-267F4BB316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34816" y="1461824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C678F83-71C8-CA0F-BD5F-5B5A6F2F37C4}"/>
              </a:ext>
            </a:extLst>
          </p:cNvPr>
          <p:cNvSpPr txBox="1"/>
          <p:nvPr/>
        </p:nvSpPr>
        <p:spPr>
          <a:xfrm>
            <a:off x="731931" y="5628922"/>
            <a:ext cx="10800034" cy="4678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buNone/>
            </a:pPr>
            <a:r>
              <a:rPr lang="en-US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Results are shown as mean (S.D.); F, results of analysis of variance; χ</a:t>
            </a:r>
            <a:r>
              <a:rPr lang="en-US" sz="1200" kern="100" baseline="300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2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, analysis of contingency tables; FET, Fisher’s exact probability test; MWUT: Mann-Whitney U test.   </a:t>
            </a:r>
            <a:r>
              <a:rPr lang="en-US" sz="1800" kern="100" dirty="0">
                <a:effectLst/>
                <a:latin typeface="Aptos" panose="020B0004020202020204" pitchFamily="34" charset="0"/>
                <a:ea typeface="DengXian" panose="02010600030101010101" pitchFamily="2" charset="-122"/>
                <a:cs typeface="Cordia New" panose="020B0304020202020204" pitchFamily="34" charset="-34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9470378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red and blue dots&#10;&#10;AI-generated content may be incorrect.">
            <a:extLst>
              <a:ext uri="{FF2B5EF4-FFF2-40B4-BE49-F238E27FC236}">
                <a16:creationId xmlns:a16="http://schemas.microsoft.com/office/drawing/2014/main" id="{9DAA9EAB-9298-08FA-6906-596687ACCEF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67"/>
          <a:stretch>
            <a:fillRect/>
          </a:stretch>
        </p:blipFill>
        <p:spPr>
          <a:xfrm>
            <a:off x="2369027" y="360263"/>
            <a:ext cx="7255231" cy="573518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635D96F-4EE4-55BB-23BD-F307144710BD}"/>
              </a:ext>
            </a:extLst>
          </p:cNvPr>
          <p:cNvSpPr txBox="1"/>
          <p:nvPr/>
        </p:nvSpPr>
        <p:spPr>
          <a:xfrm>
            <a:off x="1225985" y="6095448"/>
            <a:ext cx="931360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SF, Figure 1</a:t>
            </a:r>
            <a:r>
              <a:rPr lang="en-US" dirty="0"/>
              <a:t>. Volcano plot, with log2 fold change, of 736 metabolites in patients with major depression and healthy controls. </a:t>
            </a:r>
          </a:p>
        </p:txBody>
      </p:sp>
    </p:spTree>
    <p:extLst>
      <p:ext uri="{BB962C8B-B14F-4D97-AF65-F5344CB8AC3E}">
        <p14:creationId xmlns:p14="http://schemas.microsoft.com/office/powerpoint/2010/main" val="36833107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with red and blue dots&#10;&#10;AI-generated content may be incorrect.">
            <a:extLst>
              <a:ext uri="{FF2B5EF4-FFF2-40B4-BE49-F238E27FC236}">
                <a16:creationId xmlns:a16="http://schemas.microsoft.com/office/drawing/2014/main" id="{D400594D-3EBA-8EA6-B045-A80BE25333C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6993" y="58992"/>
            <a:ext cx="6858014" cy="548641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4F5E551-F16E-3501-F220-5DF0667D6CAB}"/>
              </a:ext>
            </a:extLst>
          </p:cNvPr>
          <p:cNvSpPr txBox="1"/>
          <p:nvPr/>
        </p:nvSpPr>
        <p:spPr>
          <a:xfrm>
            <a:off x="1002890" y="6002594"/>
            <a:ext cx="104049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SF, Figure 2</a:t>
            </a:r>
            <a:r>
              <a:rPr lang="en-US" dirty="0"/>
              <a:t>. Results of partial least squares discriminant analysis performed using 736 metabolites.</a:t>
            </a:r>
          </a:p>
        </p:txBody>
      </p:sp>
    </p:spTree>
    <p:extLst>
      <p:ext uri="{BB962C8B-B14F-4D97-AF65-F5344CB8AC3E}">
        <p14:creationId xmlns:p14="http://schemas.microsoft.com/office/powerpoint/2010/main" val="16557719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3D12E017-8B23-2BA5-6B80-9D1E234B12D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1581" y="339205"/>
            <a:ext cx="6626943" cy="530155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170D384-8A2D-5CA8-427C-6B76FAF380B3}"/>
              </a:ext>
            </a:extLst>
          </p:cNvPr>
          <p:cNvSpPr txBox="1"/>
          <p:nvPr/>
        </p:nvSpPr>
        <p:spPr>
          <a:xfrm>
            <a:off x="1002890" y="6002594"/>
            <a:ext cx="104049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SF, Figure 3</a:t>
            </a:r>
            <a:r>
              <a:rPr lang="en-US" dirty="0"/>
              <a:t>. Partial least squares discriminant analysis performed using 736 metabolites; results of permutation analysis.</a:t>
            </a:r>
          </a:p>
        </p:txBody>
      </p:sp>
    </p:spTree>
    <p:extLst>
      <p:ext uri="{BB962C8B-B14F-4D97-AF65-F5344CB8AC3E}">
        <p14:creationId xmlns:p14="http://schemas.microsoft.com/office/powerpoint/2010/main" val="24408875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FAC10F8-3AC0-2197-CD3F-3FF2B9040E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4555" y="722670"/>
            <a:ext cx="8388558" cy="488171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5B0F025-3DBB-6663-C205-068B18143287}"/>
              </a:ext>
            </a:extLst>
          </p:cNvPr>
          <p:cNvSpPr txBox="1"/>
          <p:nvPr/>
        </p:nvSpPr>
        <p:spPr>
          <a:xfrm>
            <a:off x="825910" y="5941993"/>
            <a:ext cx="1104654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ESF, Figure 4</a:t>
            </a:r>
            <a:r>
              <a:rPr lang="en-US" dirty="0"/>
              <a:t>. Results of principal component analysis performed on the testing sample using the 16 top metabolites delineated in the training sample (blue=controls; red=patients). </a:t>
            </a:r>
          </a:p>
        </p:txBody>
      </p:sp>
    </p:spTree>
    <p:extLst>
      <p:ext uri="{BB962C8B-B14F-4D97-AF65-F5344CB8AC3E}">
        <p14:creationId xmlns:p14="http://schemas.microsoft.com/office/powerpoint/2010/main" val="36584094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4</TotalTime>
  <Words>424</Words>
  <Application>Microsoft Office PowerPoint</Application>
  <PresentationFormat>Widescreen</PresentationFormat>
  <Paragraphs>8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chaelMaes MichaelMaes</dc:creator>
  <cp:lastModifiedBy>Yingqian Zhang</cp:lastModifiedBy>
  <cp:revision>27</cp:revision>
  <dcterms:created xsi:type="dcterms:W3CDTF">2025-11-29T11:42:53Z</dcterms:created>
  <dcterms:modified xsi:type="dcterms:W3CDTF">2025-12-15T13:46:31Z</dcterms:modified>
</cp:coreProperties>
</file>